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025" autoAdjust="0"/>
    <p:restoredTop sz="94660"/>
  </p:normalViewPr>
  <p:slideViewPr>
    <p:cSldViewPr snapToGrid="0">
      <p:cViewPr varScale="1">
        <p:scale>
          <a:sx n="82" d="100"/>
          <a:sy n="82" d="100"/>
        </p:scale>
        <p:origin x="231" y="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024352A-2E98-6396-2112-336C3D93930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5C1FFA1-FC88-3AD2-0509-60AFA5D0E0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F67EAC6-EC20-087E-AEFF-BF2664FB3C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3E233-235C-4254-95C8-74BDF54AA493}" type="datetimeFigureOut">
              <a:rPr kumimoji="1" lang="ja-JP" altLang="en-US" smtClean="0"/>
              <a:t>2025/9/29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0884ADF-5FAE-F3D9-777D-D7F3363EB7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1BC63A7-1C07-BC81-3A4A-B826C50D17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472BB-A2B6-4DC8-8B71-D8FC47879D3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760512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A6E57C2-4B95-C616-81F9-40D21C1C55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A951D5B-81E4-65AA-103D-22E03B1226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0FE610A-E59A-97FC-C747-0974749D27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3E233-235C-4254-95C8-74BDF54AA493}" type="datetimeFigureOut">
              <a:rPr kumimoji="1" lang="ja-JP" altLang="en-US" smtClean="0"/>
              <a:t>2025/9/29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8516804-7FC1-9F2B-FE78-BFEAD63CCD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7CDEDB9-B938-CE08-DF53-DA54E44738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472BB-A2B6-4DC8-8B71-D8FC47879D3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3998010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70BED85-3FDB-420A-107B-8F214BA6E5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0297562-AC9C-F1B4-2FBF-7CDF99044C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DDCB874-B1BF-EB7B-26C7-CE162D4C1D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3E233-235C-4254-95C8-74BDF54AA493}" type="datetimeFigureOut">
              <a:rPr kumimoji="1" lang="ja-JP" altLang="en-US" smtClean="0"/>
              <a:t>2025/9/29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A4B7514-6061-B082-3E90-D1E3561F3E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4D88448-15CB-420C-C4BE-C0DEA8121F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472BB-A2B6-4DC8-8B71-D8FC47879D3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2119878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8A8068B-4387-226F-3E28-6B2FD4E54F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5CE393F-941B-B4AA-2725-D391A4E20EC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85D649A-683A-C1FC-C227-928972F377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3E233-235C-4254-95C8-74BDF54AA493}" type="datetimeFigureOut">
              <a:rPr kumimoji="1" lang="ja-JP" altLang="en-US" smtClean="0"/>
              <a:t>2025/9/29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31D09C4-EB72-22D3-6ED6-B8B1FF124C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E4D6E1C-AB42-BCDF-378E-43421726CD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472BB-A2B6-4DC8-8B71-D8FC47879D3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6758104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AE9CE31-D51C-2077-5AC8-28379ED77C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394DA19-752E-88D3-6CA4-EC65267E03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D932D63-AD2E-C6C0-694D-C0904A1CBB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3E233-235C-4254-95C8-74BDF54AA493}" type="datetimeFigureOut">
              <a:rPr kumimoji="1" lang="ja-JP" altLang="en-US" smtClean="0"/>
              <a:t>2025/9/29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12F9069-CE20-0DBF-656E-7BC1FA0D0B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B251447-1226-2E5B-E544-FA86D4B452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472BB-A2B6-4DC8-8B71-D8FC47879D3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33111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A6A9265-5F2D-C8FF-3EE6-AF2FBED068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0119836-D023-19B7-9F52-27FCF0F1303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B73E231-D6CC-6E7C-A846-442D743518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5CF3F5E-3B9F-6C2B-B91B-5F8E1694C9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3E233-235C-4254-95C8-74BDF54AA493}" type="datetimeFigureOut">
              <a:rPr kumimoji="1" lang="ja-JP" altLang="en-US" smtClean="0"/>
              <a:t>2025/9/29</a:t>
            </a:fld>
            <a:endParaRPr kumimoji="1" lang="ja-JP" altLang="en-US" dirty="0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20236E5-A0AE-AB6D-0804-9DAB65C771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1F916F0-BA91-1464-9A62-33F9A5E562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472BB-A2B6-4DC8-8B71-D8FC47879D3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2808810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DBFC76F-F37D-130E-E0AE-A1258BAD51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E903DA2-69AC-577D-3AEA-9D7B63CC17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BDF66C9-83C1-9938-9E2A-04E0E2AF02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34246F4-CF25-5C26-2BF6-58E523A705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F547CE9-BCA5-2F41-B023-1766B65C00B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03C6316-2177-801C-008C-B8A25C843A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3E233-235C-4254-95C8-74BDF54AA493}" type="datetimeFigureOut">
              <a:rPr kumimoji="1" lang="ja-JP" altLang="en-US" smtClean="0"/>
              <a:t>2025/9/29</a:t>
            </a:fld>
            <a:endParaRPr kumimoji="1" lang="ja-JP" altLang="en-US" dirty="0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895C725-1A0B-CCA2-AD6A-9FFEDBDB8F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78C2680-DBF2-337E-560B-2A21CD426A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472BB-A2B6-4DC8-8B71-D8FC47879D3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084295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006A615-36E3-C7BC-2EEB-C9F30EC476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9D08E51-0264-68FE-DBFA-F898936766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3E233-235C-4254-95C8-74BDF54AA493}" type="datetimeFigureOut">
              <a:rPr kumimoji="1" lang="ja-JP" altLang="en-US" smtClean="0"/>
              <a:t>2025/9/29</a:t>
            </a:fld>
            <a:endParaRPr kumimoji="1" lang="ja-JP" altLang="en-US" dirty="0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39E4F25-5359-2598-F021-F025CD617B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0A8E02E-2E58-3F43-C3C0-37F5D55A5D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472BB-A2B6-4DC8-8B71-D8FC47879D3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0913127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CA222F9-D9AB-8A4C-41A2-8790D51188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3E233-235C-4254-95C8-74BDF54AA493}" type="datetimeFigureOut">
              <a:rPr kumimoji="1" lang="ja-JP" altLang="en-US" smtClean="0"/>
              <a:t>2025/9/29</a:t>
            </a:fld>
            <a:endParaRPr kumimoji="1" lang="ja-JP" altLang="en-US" dirty="0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1A6AF05-D86F-3D55-5915-70E50FEDDB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59AC4EB-DC69-527B-CF2C-0E0ADEC308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472BB-A2B6-4DC8-8B71-D8FC47879D3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079035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C460E07-5985-200B-5FE3-7F190A7C61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F7706F4-A5B6-0A09-50CC-36CAA30C5D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66862CE-5E95-5ACD-7A76-299433D8F0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8D4368F-6999-72D2-09D7-776C6CE7EE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3E233-235C-4254-95C8-74BDF54AA493}" type="datetimeFigureOut">
              <a:rPr kumimoji="1" lang="ja-JP" altLang="en-US" smtClean="0"/>
              <a:t>2025/9/29</a:t>
            </a:fld>
            <a:endParaRPr kumimoji="1" lang="ja-JP" altLang="en-US" dirty="0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30711EC-C961-2B3D-4082-24050A453C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3E7CFB9-A0AF-74CB-7C29-75924DE5F8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472BB-A2B6-4DC8-8B71-D8FC47879D3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49730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04BE0A6-BB91-73B3-33FD-EFEE932B37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60A5C7C-CC93-AEF6-601A-DDF207F5F67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FC7F092-10E2-6642-365F-DD1782119E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623E724-824A-CDD6-CB49-1B72F30556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03E233-235C-4254-95C8-74BDF54AA493}" type="datetimeFigureOut">
              <a:rPr kumimoji="1" lang="ja-JP" altLang="en-US" smtClean="0"/>
              <a:t>2025/9/29</a:t>
            </a:fld>
            <a:endParaRPr kumimoji="1" lang="ja-JP" altLang="en-US" dirty="0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C0AA4BB-6024-105A-C7B4-C787FB7689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2264853-D96B-8E4C-DBCC-F44747D3B9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472BB-A2B6-4DC8-8B71-D8FC47879D3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695091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DC6C753-57EA-CADC-5530-ADDA75A47C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C7BA889-FFF6-55ED-59DD-7F2E2C5757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AA6488D-B679-617A-28D5-1FAEECBBCFD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A03E233-235C-4254-95C8-74BDF54AA493}" type="datetimeFigureOut">
              <a:rPr kumimoji="1" lang="ja-JP" altLang="en-US" smtClean="0"/>
              <a:t>2025/9/29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0A205F5-C390-6080-C512-320191A3FC6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B5F5A6A-A13F-D592-52D2-0A2465832A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61472BB-A2B6-4DC8-8B71-D8FC47879D3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048373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5">
            <a:extLst>
              <a:ext uri="{FF2B5EF4-FFF2-40B4-BE49-F238E27FC236}">
                <a16:creationId xmlns:a16="http://schemas.microsoft.com/office/drawing/2014/main" id="{C6D5B335-3BAA-0B9F-B8B5-2B473CD8B147}"/>
              </a:ext>
            </a:extLst>
          </p:cNvPr>
          <p:cNvSpPr txBox="1"/>
          <p:nvPr/>
        </p:nvSpPr>
        <p:spPr>
          <a:xfrm>
            <a:off x="3637589" y="2827951"/>
            <a:ext cx="6399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X MC</a:t>
            </a:r>
          </a:p>
        </p:txBody>
      </p:sp>
      <p:sp>
        <p:nvSpPr>
          <p:cNvPr id="5" name="テキスト ボックス 8">
            <a:extLst>
              <a:ext uri="{FF2B5EF4-FFF2-40B4-BE49-F238E27FC236}">
                <a16:creationId xmlns:a16="http://schemas.microsoft.com/office/drawing/2014/main" id="{A6E9CB98-4CF6-7F3D-AD19-CC4C7262D80E}"/>
              </a:ext>
            </a:extLst>
          </p:cNvPr>
          <p:cNvSpPr txBox="1"/>
          <p:nvPr/>
        </p:nvSpPr>
        <p:spPr>
          <a:xfrm>
            <a:off x="2628469" y="3202985"/>
            <a:ext cx="6399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X MC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13">
            <a:extLst>
              <a:ext uri="{FF2B5EF4-FFF2-40B4-BE49-F238E27FC236}">
                <a16:creationId xmlns:a16="http://schemas.microsoft.com/office/drawing/2014/main" id="{59796112-57E2-45FB-E523-E5145C3D9E3B}"/>
              </a:ext>
            </a:extLst>
          </p:cNvPr>
          <p:cNvSpPr txBox="1"/>
          <p:nvPr/>
        </p:nvSpPr>
        <p:spPr>
          <a:xfrm>
            <a:off x="3591978" y="4698930"/>
            <a:ext cx="5886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X GP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0629100A-B304-D1E4-689B-0564B55B6C62}"/>
              </a:ext>
            </a:extLst>
          </p:cNvPr>
          <p:cNvCxnSpPr>
            <a:cxnSpLocks/>
          </p:cNvCxnSpPr>
          <p:nvPr/>
        </p:nvCxnSpPr>
        <p:spPr>
          <a:xfrm>
            <a:off x="1076073" y="1944480"/>
            <a:ext cx="294595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18">
            <a:extLst>
              <a:ext uri="{FF2B5EF4-FFF2-40B4-BE49-F238E27FC236}">
                <a16:creationId xmlns:a16="http://schemas.microsoft.com/office/drawing/2014/main" id="{95EC3E4E-3097-E828-6827-E0812DCFB88B}"/>
              </a:ext>
            </a:extLst>
          </p:cNvPr>
          <p:cNvSpPr txBox="1"/>
          <p:nvPr/>
        </p:nvSpPr>
        <p:spPr>
          <a:xfrm>
            <a:off x="3903261" y="1783823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ja-JP" altLang="en-US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〇</a:t>
            </a:r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24">
            <a:extLst>
              <a:ext uri="{FF2B5EF4-FFF2-40B4-BE49-F238E27FC236}">
                <a16:creationId xmlns:a16="http://schemas.microsoft.com/office/drawing/2014/main" id="{E53EB51E-4C30-BC47-502C-2421AA3CB033}"/>
              </a:ext>
            </a:extLst>
          </p:cNvPr>
          <p:cNvSpPr txBox="1"/>
          <p:nvPr/>
        </p:nvSpPr>
        <p:spPr>
          <a:xfrm>
            <a:off x="4588529" y="2109313"/>
            <a:ext cx="4090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ja-JP" altLang="en-US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〇</a:t>
            </a:r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25">
            <a:extLst>
              <a:ext uri="{FF2B5EF4-FFF2-40B4-BE49-F238E27FC236}">
                <a16:creationId xmlns:a16="http://schemas.microsoft.com/office/drawing/2014/main" id="{513F9670-2C1E-DDAF-1F30-9834BFB1AB90}"/>
              </a:ext>
            </a:extLst>
          </p:cNvPr>
          <p:cNvSpPr txBox="1"/>
          <p:nvPr/>
        </p:nvSpPr>
        <p:spPr>
          <a:xfrm>
            <a:off x="5111641" y="2444619"/>
            <a:ext cx="4090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ja-JP" altLang="en-US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〇</a:t>
            </a:r>
            <a:r>
              <a:rPr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D080ED71-9E06-B0E1-D25A-03540A7EF59A}"/>
              </a:ext>
            </a:extLst>
          </p:cNvPr>
          <p:cNvCxnSpPr>
            <a:cxnSpLocks/>
          </p:cNvCxnSpPr>
          <p:nvPr/>
        </p:nvCxnSpPr>
        <p:spPr>
          <a:xfrm flipH="1">
            <a:off x="1068124" y="1682530"/>
            <a:ext cx="10944" cy="3516679"/>
          </a:xfrm>
          <a:prstGeom prst="line">
            <a:avLst/>
          </a:prstGeom>
          <a:ln w="28575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1FDA9C9B-62B6-4113-8BA2-D36CB8589B93}"/>
              </a:ext>
            </a:extLst>
          </p:cNvPr>
          <p:cNvCxnSpPr>
            <a:cxnSpLocks/>
          </p:cNvCxnSpPr>
          <p:nvPr/>
        </p:nvCxnSpPr>
        <p:spPr>
          <a:xfrm>
            <a:off x="1080048" y="5191328"/>
            <a:ext cx="4440679" cy="7881"/>
          </a:xfrm>
          <a:prstGeom prst="line">
            <a:avLst/>
          </a:prstGeom>
          <a:ln w="28575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30">
            <a:extLst>
              <a:ext uri="{FF2B5EF4-FFF2-40B4-BE49-F238E27FC236}">
                <a16:creationId xmlns:a16="http://schemas.microsoft.com/office/drawing/2014/main" id="{412B81A1-221B-5C9B-1BA1-74BFD803F7E1}"/>
              </a:ext>
            </a:extLst>
          </p:cNvPr>
          <p:cNvSpPr txBox="1"/>
          <p:nvPr/>
        </p:nvSpPr>
        <p:spPr>
          <a:xfrm>
            <a:off x="449249" y="1763416"/>
            <a:ext cx="4399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1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31">
            <a:extLst>
              <a:ext uri="{FF2B5EF4-FFF2-40B4-BE49-F238E27FC236}">
                <a16:creationId xmlns:a16="http://schemas.microsoft.com/office/drawing/2014/main" id="{B32A1E67-2337-3F0C-301A-41CCBD603C01}"/>
              </a:ext>
            </a:extLst>
          </p:cNvPr>
          <p:cNvSpPr txBox="1"/>
          <p:nvPr/>
        </p:nvSpPr>
        <p:spPr>
          <a:xfrm>
            <a:off x="449249" y="2122759"/>
            <a:ext cx="383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2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32">
            <a:extLst>
              <a:ext uri="{FF2B5EF4-FFF2-40B4-BE49-F238E27FC236}">
                <a16:creationId xmlns:a16="http://schemas.microsoft.com/office/drawing/2014/main" id="{0C950FEF-964D-4D49-18AC-124677E7300D}"/>
              </a:ext>
            </a:extLst>
          </p:cNvPr>
          <p:cNvSpPr txBox="1"/>
          <p:nvPr/>
        </p:nvSpPr>
        <p:spPr>
          <a:xfrm>
            <a:off x="449249" y="2481161"/>
            <a:ext cx="4706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3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33">
            <a:extLst>
              <a:ext uri="{FF2B5EF4-FFF2-40B4-BE49-F238E27FC236}">
                <a16:creationId xmlns:a16="http://schemas.microsoft.com/office/drawing/2014/main" id="{C4C47BD5-0C3E-A2F5-0D17-4A2FB629180B}"/>
              </a:ext>
            </a:extLst>
          </p:cNvPr>
          <p:cNvSpPr txBox="1"/>
          <p:nvPr/>
        </p:nvSpPr>
        <p:spPr>
          <a:xfrm>
            <a:off x="449249" y="2846920"/>
            <a:ext cx="4209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4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34">
            <a:extLst>
              <a:ext uri="{FF2B5EF4-FFF2-40B4-BE49-F238E27FC236}">
                <a16:creationId xmlns:a16="http://schemas.microsoft.com/office/drawing/2014/main" id="{5F7B4A62-928A-0DE8-4765-63CF0AD7177B}"/>
              </a:ext>
            </a:extLst>
          </p:cNvPr>
          <p:cNvSpPr txBox="1"/>
          <p:nvPr/>
        </p:nvSpPr>
        <p:spPr>
          <a:xfrm>
            <a:off x="449249" y="3219362"/>
            <a:ext cx="4008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5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35">
            <a:extLst>
              <a:ext uri="{FF2B5EF4-FFF2-40B4-BE49-F238E27FC236}">
                <a16:creationId xmlns:a16="http://schemas.microsoft.com/office/drawing/2014/main" id="{2896637A-339E-897D-0C18-4195A3D092B0}"/>
              </a:ext>
            </a:extLst>
          </p:cNvPr>
          <p:cNvSpPr txBox="1"/>
          <p:nvPr/>
        </p:nvSpPr>
        <p:spPr>
          <a:xfrm>
            <a:off x="449249" y="3588966"/>
            <a:ext cx="4209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6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36">
            <a:extLst>
              <a:ext uri="{FF2B5EF4-FFF2-40B4-BE49-F238E27FC236}">
                <a16:creationId xmlns:a16="http://schemas.microsoft.com/office/drawing/2014/main" id="{D2740C6C-54D8-B4A3-EC3F-2ECCC82D6FA7}"/>
              </a:ext>
            </a:extLst>
          </p:cNvPr>
          <p:cNvSpPr txBox="1"/>
          <p:nvPr/>
        </p:nvSpPr>
        <p:spPr>
          <a:xfrm>
            <a:off x="449249" y="3960088"/>
            <a:ext cx="4209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7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37">
            <a:extLst>
              <a:ext uri="{FF2B5EF4-FFF2-40B4-BE49-F238E27FC236}">
                <a16:creationId xmlns:a16="http://schemas.microsoft.com/office/drawing/2014/main" id="{B57D46D7-5806-0B83-7DE0-EE9D97CE4878}"/>
              </a:ext>
            </a:extLst>
          </p:cNvPr>
          <p:cNvSpPr txBox="1"/>
          <p:nvPr/>
        </p:nvSpPr>
        <p:spPr>
          <a:xfrm>
            <a:off x="5750740" y="1748419"/>
            <a:ext cx="5473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1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38">
            <a:extLst>
              <a:ext uri="{FF2B5EF4-FFF2-40B4-BE49-F238E27FC236}">
                <a16:creationId xmlns:a16="http://schemas.microsoft.com/office/drawing/2014/main" id="{F265E6EF-AA52-B844-C6C2-6CB72C0B3425}"/>
              </a:ext>
            </a:extLst>
          </p:cNvPr>
          <p:cNvSpPr txBox="1"/>
          <p:nvPr/>
        </p:nvSpPr>
        <p:spPr>
          <a:xfrm>
            <a:off x="5750740" y="2091720"/>
            <a:ext cx="5473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1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39">
            <a:extLst>
              <a:ext uri="{FF2B5EF4-FFF2-40B4-BE49-F238E27FC236}">
                <a16:creationId xmlns:a16="http://schemas.microsoft.com/office/drawing/2014/main" id="{EC95F775-5816-405C-0B00-8578D296BBD1}"/>
              </a:ext>
            </a:extLst>
          </p:cNvPr>
          <p:cNvSpPr txBox="1"/>
          <p:nvPr/>
        </p:nvSpPr>
        <p:spPr>
          <a:xfrm>
            <a:off x="5750740" y="2449459"/>
            <a:ext cx="5473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1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40">
            <a:extLst>
              <a:ext uri="{FF2B5EF4-FFF2-40B4-BE49-F238E27FC236}">
                <a16:creationId xmlns:a16="http://schemas.microsoft.com/office/drawing/2014/main" id="{C2D495C9-EB15-A25C-633B-E75B5F2F6AAD}"/>
              </a:ext>
            </a:extLst>
          </p:cNvPr>
          <p:cNvSpPr txBox="1"/>
          <p:nvPr/>
        </p:nvSpPr>
        <p:spPr>
          <a:xfrm>
            <a:off x="5750740" y="2823309"/>
            <a:ext cx="5473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2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41">
            <a:extLst>
              <a:ext uri="{FF2B5EF4-FFF2-40B4-BE49-F238E27FC236}">
                <a16:creationId xmlns:a16="http://schemas.microsoft.com/office/drawing/2014/main" id="{E3933C80-F01A-F469-77A2-0C3CDA528CE9}"/>
              </a:ext>
            </a:extLst>
          </p:cNvPr>
          <p:cNvSpPr txBox="1"/>
          <p:nvPr/>
        </p:nvSpPr>
        <p:spPr>
          <a:xfrm>
            <a:off x="5750740" y="3204832"/>
            <a:ext cx="5473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2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42">
            <a:extLst>
              <a:ext uri="{FF2B5EF4-FFF2-40B4-BE49-F238E27FC236}">
                <a16:creationId xmlns:a16="http://schemas.microsoft.com/office/drawing/2014/main" id="{1D8EF9E6-4294-C25E-2A02-7610C0D49C0F}"/>
              </a:ext>
            </a:extLst>
          </p:cNvPr>
          <p:cNvSpPr txBox="1"/>
          <p:nvPr/>
        </p:nvSpPr>
        <p:spPr>
          <a:xfrm>
            <a:off x="5750740" y="4668362"/>
            <a:ext cx="5473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3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44">
            <a:extLst>
              <a:ext uri="{FF2B5EF4-FFF2-40B4-BE49-F238E27FC236}">
                <a16:creationId xmlns:a16="http://schemas.microsoft.com/office/drawing/2014/main" id="{EAB92B2D-9B67-0870-C471-9BE2C0AD74F7}"/>
              </a:ext>
            </a:extLst>
          </p:cNvPr>
          <p:cNvSpPr txBox="1"/>
          <p:nvPr/>
        </p:nvSpPr>
        <p:spPr>
          <a:xfrm>
            <a:off x="4466711" y="5247760"/>
            <a:ext cx="8889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months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45">
            <a:extLst>
              <a:ext uri="{FF2B5EF4-FFF2-40B4-BE49-F238E27FC236}">
                <a16:creationId xmlns:a16="http://schemas.microsoft.com/office/drawing/2014/main" id="{2DEC100E-D722-6FCE-459D-30654558EB8A}"/>
              </a:ext>
            </a:extLst>
          </p:cNvPr>
          <p:cNvSpPr txBox="1"/>
          <p:nvPr/>
        </p:nvSpPr>
        <p:spPr>
          <a:xfrm>
            <a:off x="6287837" y="1308520"/>
            <a:ext cx="21993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LED</a:t>
            </a:r>
            <a:r>
              <a:rPr kumimoji="1" lang="ja-JP" altLang="en-US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mg) </a:t>
            </a:r>
            <a:r>
              <a:rPr lang="ja-JP" altLang="en-US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46">
            <a:extLst>
              <a:ext uri="{FF2B5EF4-FFF2-40B4-BE49-F238E27FC236}">
                <a16:creationId xmlns:a16="http://schemas.microsoft.com/office/drawing/2014/main" id="{5D994E7C-3E28-7FB4-DF67-23A38FEE914A}"/>
              </a:ext>
            </a:extLst>
          </p:cNvPr>
          <p:cNvSpPr txBox="1"/>
          <p:nvPr/>
        </p:nvSpPr>
        <p:spPr>
          <a:xfrm>
            <a:off x="6295857" y="2095048"/>
            <a:ext cx="54468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LED</a:t>
            </a:r>
            <a:r>
              <a:rPr lang="ja-JP" altLang="en-US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399</a:t>
            </a:r>
            <a:r>
              <a:rPr lang="ja-JP" altLang="en-US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mg) at </a:t>
            </a:r>
            <a:r>
              <a:rPr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24 months after the introduction of medical treatment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47">
            <a:extLst>
              <a:ext uri="{FF2B5EF4-FFF2-40B4-BE49-F238E27FC236}">
                <a16:creationId xmlns:a16="http://schemas.microsoft.com/office/drawing/2014/main" id="{E6594582-AF77-A82B-9272-85BEF2078423}"/>
              </a:ext>
            </a:extLst>
          </p:cNvPr>
          <p:cNvSpPr txBox="1"/>
          <p:nvPr/>
        </p:nvSpPr>
        <p:spPr>
          <a:xfrm>
            <a:off x="6295858" y="2444979"/>
            <a:ext cx="55913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LED</a:t>
            </a:r>
            <a:r>
              <a:rPr lang="ja-JP" altLang="en-US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300 mg) at 24 months after the introduction of medical treatment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48">
            <a:extLst>
              <a:ext uri="{FF2B5EF4-FFF2-40B4-BE49-F238E27FC236}">
                <a16:creationId xmlns:a16="http://schemas.microsoft.com/office/drawing/2014/main" id="{1F5F5D67-1253-242F-3113-8B466F3CDCEA}"/>
              </a:ext>
            </a:extLst>
          </p:cNvPr>
          <p:cNvSpPr txBox="1"/>
          <p:nvPr/>
        </p:nvSpPr>
        <p:spPr>
          <a:xfrm>
            <a:off x="6303879" y="2826708"/>
            <a:ext cx="33374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LED (300 </a:t>
            </a:r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mg) at the experience of MC 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1">
            <a:extLst>
              <a:ext uri="{FF2B5EF4-FFF2-40B4-BE49-F238E27FC236}">
                <a16:creationId xmlns:a16="http://schemas.microsoft.com/office/drawing/2014/main" id="{14F7199F-5EAA-74C0-94E4-C90CE94010DB}"/>
              </a:ext>
            </a:extLst>
          </p:cNvPr>
          <p:cNvSpPr txBox="1"/>
          <p:nvPr/>
        </p:nvSpPr>
        <p:spPr>
          <a:xfrm>
            <a:off x="449249" y="4318576"/>
            <a:ext cx="4101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8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">
            <a:extLst>
              <a:ext uri="{FF2B5EF4-FFF2-40B4-BE49-F238E27FC236}">
                <a16:creationId xmlns:a16="http://schemas.microsoft.com/office/drawing/2014/main" id="{3CA5119A-3F21-34B4-CD8A-2AC8CD121A19}"/>
              </a:ext>
            </a:extLst>
          </p:cNvPr>
          <p:cNvSpPr txBox="1"/>
          <p:nvPr/>
        </p:nvSpPr>
        <p:spPr>
          <a:xfrm>
            <a:off x="449249" y="4725457"/>
            <a:ext cx="4399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9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17">
            <a:extLst>
              <a:ext uri="{FF2B5EF4-FFF2-40B4-BE49-F238E27FC236}">
                <a16:creationId xmlns:a16="http://schemas.microsoft.com/office/drawing/2014/main" id="{BBE80FDB-2272-F798-278B-186D5A192BCF}"/>
              </a:ext>
            </a:extLst>
          </p:cNvPr>
          <p:cNvSpPr txBox="1"/>
          <p:nvPr/>
        </p:nvSpPr>
        <p:spPr>
          <a:xfrm>
            <a:off x="2754090" y="4336328"/>
            <a:ext cx="5886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X GP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21">
            <a:extLst>
              <a:ext uri="{FF2B5EF4-FFF2-40B4-BE49-F238E27FC236}">
                <a16:creationId xmlns:a16="http://schemas.microsoft.com/office/drawing/2014/main" id="{E089684A-A53C-7788-6602-0ECD2821E4B3}"/>
              </a:ext>
            </a:extLst>
          </p:cNvPr>
          <p:cNvSpPr txBox="1"/>
          <p:nvPr/>
        </p:nvSpPr>
        <p:spPr>
          <a:xfrm>
            <a:off x="5750740" y="4327646"/>
            <a:ext cx="5473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3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28">
            <a:extLst>
              <a:ext uri="{FF2B5EF4-FFF2-40B4-BE49-F238E27FC236}">
                <a16:creationId xmlns:a16="http://schemas.microsoft.com/office/drawing/2014/main" id="{2C60E77B-9FF5-B136-6018-0507AF15B797}"/>
              </a:ext>
            </a:extLst>
          </p:cNvPr>
          <p:cNvSpPr txBox="1"/>
          <p:nvPr/>
        </p:nvSpPr>
        <p:spPr>
          <a:xfrm>
            <a:off x="2246182" y="3931698"/>
            <a:ext cx="5886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X GP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54">
            <a:extLst>
              <a:ext uri="{FF2B5EF4-FFF2-40B4-BE49-F238E27FC236}">
                <a16:creationId xmlns:a16="http://schemas.microsoft.com/office/drawing/2014/main" id="{6D99A9F3-F0D1-B945-3F31-29576B95E671}"/>
              </a:ext>
            </a:extLst>
          </p:cNvPr>
          <p:cNvSpPr txBox="1"/>
          <p:nvPr/>
        </p:nvSpPr>
        <p:spPr>
          <a:xfrm>
            <a:off x="5750740" y="3955783"/>
            <a:ext cx="5473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3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57">
            <a:extLst>
              <a:ext uri="{FF2B5EF4-FFF2-40B4-BE49-F238E27FC236}">
                <a16:creationId xmlns:a16="http://schemas.microsoft.com/office/drawing/2014/main" id="{26FC1845-FD7F-79C3-8F56-8152338E735E}"/>
              </a:ext>
            </a:extLst>
          </p:cNvPr>
          <p:cNvSpPr txBox="1"/>
          <p:nvPr/>
        </p:nvSpPr>
        <p:spPr>
          <a:xfrm>
            <a:off x="4003499" y="3570000"/>
            <a:ext cx="6399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X MC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59">
            <a:extLst>
              <a:ext uri="{FF2B5EF4-FFF2-40B4-BE49-F238E27FC236}">
                <a16:creationId xmlns:a16="http://schemas.microsoft.com/office/drawing/2014/main" id="{DC091C21-C0D2-6EBD-0DF1-CA9248B18C96}"/>
              </a:ext>
            </a:extLst>
          </p:cNvPr>
          <p:cNvSpPr txBox="1"/>
          <p:nvPr/>
        </p:nvSpPr>
        <p:spPr>
          <a:xfrm>
            <a:off x="5750740" y="3596052"/>
            <a:ext cx="5473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2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60">
            <a:extLst>
              <a:ext uri="{FF2B5EF4-FFF2-40B4-BE49-F238E27FC236}">
                <a16:creationId xmlns:a16="http://schemas.microsoft.com/office/drawing/2014/main" id="{0994CC0A-C97A-6CC5-1E91-23F67F2C7697}"/>
              </a:ext>
            </a:extLst>
          </p:cNvPr>
          <p:cNvSpPr txBox="1"/>
          <p:nvPr/>
        </p:nvSpPr>
        <p:spPr>
          <a:xfrm>
            <a:off x="6303879" y="3201398"/>
            <a:ext cx="30780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LED (300 </a:t>
            </a:r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mg) at the experience of MC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61">
            <a:extLst>
              <a:ext uri="{FF2B5EF4-FFF2-40B4-BE49-F238E27FC236}">
                <a16:creationId xmlns:a16="http://schemas.microsoft.com/office/drawing/2014/main" id="{22296D59-0F02-2564-DDF4-8A79C1C60202}"/>
              </a:ext>
            </a:extLst>
          </p:cNvPr>
          <p:cNvSpPr txBox="1"/>
          <p:nvPr/>
        </p:nvSpPr>
        <p:spPr>
          <a:xfrm>
            <a:off x="6295858" y="3592476"/>
            <a:ext cx="31870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LED (400 </a:t>
            </a:r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mg) at the experience of MC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62">
            <a:extLst>
              <a:ext uri="{FF2B5EF4-FFF2-40B4-BE49-F238E27FC236}">
                <a16:creationId xmlns:a16="http://schemas.microsoft.com/office/drawing/2014/main" id="{6FE09DEB-B981-D00B-06CB-A369813499DE}"/>
              </a:ext>
            </a:extLst>
          </p:cNvPr>
          <p:cNvSpPr txBox="1"/>
          <p:nvPr/>
        </p:nvSpPr>
        <p:spPr>
          <a:xfrm>
            <a:off x="6295858" y="3967582"/>
            <a:ext cx="31932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LED (150 </a:t>
            </a:r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mg) at the experience of GP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63">
            <a:extLst>
              <a:ext uri="{FF2B5EF4-FFF2-40B4-BE49-F238E27FC236}">
                <a16:creationId xmlns:a16="http://schemas.microsoft.com/office/drawing/2014/main" id="{175CCB56-92B4-A6E8-C577-4ED8524D0D85}"/>
              </a:ext>
            </a:extLst>
          </p:cNvPr>
          <p:cNvSpPr txBox="1"/>
          <p:nvPr/>
        </p:nvSpPr>
        <p:spPr>
          <a:xfrm>
            <a:off x="6287837" y="4333415"/>
            <a:ext cx="30525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LED (200 </a:t>
            </a:r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mg) at the experience of GP</a:t>
            </a:r>
            <a:r>
              <a:rPr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64">
            <a:extLst>
              <a:ext uri="{FF2B5EF4-FFF2-40B4-BE49-F238E27FC236}">
                <a16:creationId xmlns:a16="http://schemas.microsoft.com/office/drawing/2014/main" id="{F1A6B9E4-9E3A-BE62-1CCD-F57C3F785474}"/>
              </a:ext>
            </a:extLst>
          </p:cNvPr>
          <p:cNvSpPr txBox="1"/>
          <p:nvPr/>
        </p:nvSpPr>
        <p:spPr>
          <a:xfrm>
            <a:off x="6287837" y="4698860"/>
            <a:ext cx="31552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LED (300 </a:t>
            </a:r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mg) at the experience of GP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18">
            <a:extLst>
              <a:ext uri="{FF2B5EF4-FFF2-40B4-BE49-F238E27FC236}">
                <a16:creationId xmlns:a16="http://schemas.microsoft.com/office/drawing/2014/main" id="{731A7FCE-FB15-32B1-FF89-78544D0ED348}"/>
              </a:ext>
            </a:extLst>
          </p:cNvPr>
          <p:cNvSpPr txBox="1"/>
          <p:nvPr/>
        </p:nvSpPr>
        <p:spPr>
          <a:xfrm>
            <a:off x="5555587" y="1294543"/>
            <a:ext cx="6944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ja-JP" altLang="en-US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Group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6">
            <a:extLst>
              <a:ext uri="{FF2B5EF4-FFF2-40B4-BE49-F238E27FC236}">
                <a16:creationId xmlns:a16="http://schemas.microsoft.com/office/drawing/2014/main" id="{3E3A801A-AE67-1F06-B6E6-10BD90128ADC}"/>
              </a:ext>
            </a:extLst>
          </p:cNvPr>
          <p:cNvSpPr txBox="1"/>
          <p:nvPr/>
        </p:nvSpPr>
        <p:spPr>
          <a:xfrm>
            <a:off x="6294872" y="1750146"/>
            <a:ext cx="54289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LED</a:t>
            </a:r>
            <a:r>
              <a:rPr lang="ja-JP" altLang="en-US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(212.5 </a:t>
            </a:r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mg) at </a:t>
            </a:r>
            <a:r>
              <a:rPr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24 months after the introduction of medical treatment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18">
            <a:extLst>
              <a:ext uri="{FF2B5EF4-FFF2-40B4-BE49-F238E27FC236}">
                <a16:creationId xmlns:a16="http://schemas.microsoft.com/office/drawing/2014/main" id="{7A76281E-F64D-8BE8-F468-4DB8B90F1FD6}"/>
              </a:ext>
            </a:extLst>
          </p:cNvPr>
          <p:cNvSpPr txBox="1"/>
          <p:nvPr/>
        </p:nvSpPr>
        <p:spPr>
          <a:xfrm>
            <a:off x="112099" y="1246417"/>
            <a:ext cx="1321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ja-JP" altLang="en-US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atient</a:t>
            </a:r>
            <a:r>
              <a:rPr lang="ja-JP" altLang="en-US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number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4">
            <a:extLst>
              <a:ext uri="{FF2B5EF4-FFF2-40B4-BE49-F238E27FC236}">
                <a16:creationId xmlns:a16="http://schemas.microsoft.com/office/drawing/2014/main" id="{FBC967B9-C512-577F-FAC5-EF22CFFEE339}"/>
              </a:ext>
            </a:extLst>
          </p:cNvPr>
          <p:cNvSpPr txBox="1"/>
          <p:nvPr/>
        </p:nvSpPr>
        <p:spPr>
          <a:xfrm>
            <a:off x="1330884" y="5255380"/>
            <a:ext cx="14396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rtl="0">
              <a:defRPr lang="ja-jp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linical course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6E9F898D-3EF5-9E70-9F02-464EFD8BF955}"/>
              </a:ext>
            </a:extLst>
          </p:cNvPr>
          <p:cNvCxnSpPr>
            <a:cxnSpLocks/>
          </p:cNvCxnSpPr>
          <p:nvPr/>
        </p:nvCxnSpPr>
        <p:spPr>
          <a:xfrm>
            <a:off x="1637544" y="2273342"/>
            <a:ext cx="294595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5473D707-7D8E-11C5-ACD2-C3E88D28B3EB}"/>
              </a:ext>
            </a:extLst>
          </p:cNvPr>
          <p:cNvCxnSpPr>
            <a:cxnSpLocks/>
          </p:cNvCxnSpPr>
          <p:nvPr/>
        </p:nvCxnSpPr>
        <p:spPr>
          <a:xfrm>
            <a:off x="2054636" y="2602203"/>
            <a:ext cx="294595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889C32D9-E413-0B14-4A4C-8F268BAEF831}"/>
              </a:ext>
            </a:extLst>
          </p:cNvPr>
          <p:cNvCxnSpPr>
            <a:cxnSpLocks/>
          </p:cNvCxnSpPr>
          <p:nvPr/>
        </p:nvCxnSpPr>
        <p:spPr>
          <a:xfrm>
            <a:off x="1084095" y="2979190"/>
            <a:ext cx="243715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8DD8E587-98EF-F477-F803-F1C1F693A1DC}"/>
              </a:ext>
            </a:extLst>
          </p:cNvPr>
          <p:cNvCxnSpPr>
            <a:cxnSpLocks/>
          </p:cNvCxnSpPr>
          <p:nvPr/>
        </p:nvCxnSpPr>
        <p:spPr>
          <a:xfrm>
            <a:off x="1244516" y="3356177"/>
            <a:ext cx="131420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1389A71B-048F-7D42-278C-4840BB16BC55}"/>
              </a:ext>
            </a:extLst>
          </p:cNvPr>
          <p:cNvCxnSpPr>
            <a:cxnSpLocks/>
          </p:cNvCxnSpPr>
          <p:nvPr/>
        </p:nvCxnSpPr>
        <p:spPr>
          <a:xfrm>
            <a:off x="1629524" y="3725144"/>
            <a:ext cx="227373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D73BF338-40D3-EFAD-8883-F406205BB905}"/>
              </a:ext>
            </a:extLst>
          </p:cNvPr>
          <p:cNvCxnSpPr>
            <a:cxnSpLocks/>
          </p:cNvCxnSpPr>
          <p:nvPr/>
        </p:nvCxnSpPr>
        <p:spPr>
          <a:xfrm>
            <a:off x="1092116" y="4094122"/>
            <a:ext cx="115378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A55122F6-388C-B261-15AD-38F1756BAF14}"/>
              </a:ext>
            </a:extLst>
          </p:cNvPr>
          <p:cNvCxnSpPr>
            <a:cxnSpLocks/>
          </p:cNvCxnSpPr>
          <p:nvPr/>
        </p:nvCxnSpPr>
        <p:spPr>
          <a:xfrm>
            <a:off x="1886196" y="4487152"/>
            <a:ext cx="88432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64B9B2B5-DB9E-C1A0-4D97-21EBCE292123}"/>
              </a:ext>
            </a:extLst>
          </p:cNvPr>
          <p:cNvCxnSpPr>
            <a:cxnSpLocks/>
          </p:cNvCxnSpPr>
          <p:nvPr/>
        </p:nvCxnSpPr>
        <p:spPr>
          <a:xfrm>
            <a:off x="1244516" y="4864139"/>
            <a:ext cx="22125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7767F31-710B-DC9E-7F48-0A2DB61FE4CE}"/>
              </a:ext>
            </a:extLst>
          </p:cNvPr>
          <p:cNvSpPr txBox="1"/>
          <p:nvPr/>
        </p:nvSpPr>
        <p:spPr>
          <a:xfrm>
            <a:off x="376989" y="280282"/>
            <a:ext cx="11670632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ppl. Figure 1. Clinical course and endpoint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, definition of </a:t>
            </a:r>
            <a:r>
              <a:rPr lang="en-US" altLang="ja-JP" sz="1400" dirty="0">
                <a:latin typeface="Times New Roman" panose="02020603050405020304" pitchFamily="18" charset="0"/>
                <a:ea typeface="游明朝" panose="02020400000000000000" pitchFamily="18" charset="-128"/>
              </a:rPr>
              <a:t>the 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LED 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at the endpoint, and 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mmary of the categorization of </a:t>
            </a:r>
            <a:r>
              <a:rPr lang="en-US" altLang="ja-JP" sz="1400" dirty="0">
                <a:latin typeface="Times New Roman" panose="02020603050405020304" pitchFamily="18" charset="0"/>
                <a:ea typeface="游明朝" panose="02020400000000000000" pitchFamily="18" charset="-128"/>
              </a:rPr>
              <a:t>nine representative patients 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into 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Groups 1–3. </a:t>
            </a:r>
            <a:endParaRPr lang="ja-JP" altLang="en-US" sz="1400" dirty="0"/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22E64379-8092-315E-93AB-A2873294BD79}"/>
              </a:ext>
            </a:extLst>
          </p:cNvPr>
          <p:cNvSpPr txBox="1"/>
          <p:nvPr/>
        </p:nvSpPr>
        <p:spPr>
          <a:xfrm>
            <a:off x="473244" y="5871239"/>
            <a:ext cx="10539662" cy="46294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○, the patient did not experience MC or GP; X, the patient experienced either MC or GP; MC, motor complications; GP, gait problems. </a:t>
            </a:r>
            <a:endParaRPr lang="ja-JP" altLang="ja-JP" sz="1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01729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0</Words>
  <Application>Microsoft Office PowerPoint</Application>
  <PresentationFormat>ワイド画面</PresentationFormat>
  <Paragraphs>4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24-09-30T11:57:33Z</dcterms:created>
  <dcterms:modified xsi:type="dcterms:W3CDTF">2025-09-29T10:14:01Z</dcterms:modified>
</cp:coreProperties>
</file>